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114" y="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phe.gov.uk\porton\SharedData\Diagnostic_Technologies\Papers%20under%20construction\TB%20Protein%20Biomarker%20paper\TB%20Protein%20Biomarker%20Paper%20working%20draft\Latest%20Draft\Final\Supplementary%20Information%201%20Final%20Final%20with%20figur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phe.gov.uk\porton\SharedData\Diagnostic_Technologies\Papers%20under%20construction\TB%20Protein%20Biomarker%20paper\TB%20Protein%20Biomarker%20Paper%20working%20draft\Latest%20Draft\Final\Supplementary%20Information%201%20Final%20Final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66029110158248E-2"/>
          <c:y val="7.7511059127311738E-2"/>
          <c:w val="0.87797846374051858"/>
          <c:h val="0.81993488019875249"/>
        </c:manualLayout>
      </c:layout>
      <c:lineChart>
        <c:grouping val="standard"/>
        <c:varyColors val="0"/>
        <c:ser>
          <c:idx val="0"/>
          <c:order val="0"/>
          <c:tx>
            <c:strRef>
              <c:f>'\\phe.gov.uk\porton\SharedData\Diagnostic_Technologies\Papers under construction\TB Protein Biomarker paper\TB Protein Biomarker Paper working draft\Latest Draft\Final\[Copy of Supplementary Information 1d.xlsx]Sheet1'!$Y$8</c:f>
              <c:strCache>
                <c:ptCount val="1"/>
                <c:pt idx="0">
                  <c:v>P-CNTRL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square"/>
            <c:size val="8"/>
            <c:spPr>
              <a:solidFill>
                <a:schemeClr val="tx1"/>
              </a:solidFill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\\phe.gov.uk\porton\SharedData\Diagnostic_Technologies\Papers under construction\TB Protein Biomarker paper\TB Protein Biomarker Paper working draft\Latest Draft\Final\[Copy of Supplementary Information 1d.xlsx]Sheet1'!$Z$1:$AH$1</c:f>
              <c:strCache>
                <c:ptCount val="9"/>
                <c:pt idx="0">
                  <c:v>SAMD9L</c:v>
                </c:pt>
                <c:pt idx="1">
                  <c:v>CALCOCO2</c:v>
                </c:pt>
                <c:pt idx="2">
                  <c:v>GBP1</c:v>
                </c:pt>
                <c:pt idx="3">
                  <c:v>IFITM3</c:v>
                </c:pt>
                <c:pt idx="4">
                  <c:v>SNX10</c:v>
                </c:pt>
                <c:pt idx="5">
                  <c:v>IFIT3</c:v>
                </c:pt>
                <c:pt idx="6">
                  <c:v>CD52</c:v>
                </c:pt>
                <c:pt idx="7">
                  <c:v>CD274</c:v>
                </c:pt>
                <c:pt idx="8">
                  <c:v>TMEM49</c:v>
                </c:pt>
              </c:strCache>
            </c:strRef>
          </c:cat>
          <c:val>
            <c:numRef>
              <c:f>'\\phe.gov.uk\porton\SharedData\Diagnostic_Technologies\Papers under construction\TB Protein Biomarker paper\TB Protein Biomarker Paper working draft\Latest Draft\Final\[Copy of Supplementary Information 1d.xlsx]Sheet1'!$Z$8:$AH$8</c:f>
              <c:numCache>
                <c:formatCode>General</c:formatCode>
                <c:ptCount val="9"/>
                <c:pt idx="0">
                  <c:v>973.61786631910797</c:v>
                </c:pt>
                <c:pt idx="1">
                  <c:v>1201.1946701002489</c:v>
                </c:pt>
                <c:pt idx="2">
                  <c:v>1903.0698680713542</c:v>
                </c:pt>
                <c:pt idx="3">
                  <c:v>1110.292014678899</c:v>
                </c:pt>
                <c:pt idx="4">
                  <c:v>2017.8900205995394</c:v>
                </c:pt>
                <c:pt idx="5">
                  <c:v>0</c:v>
                </c:pt>
                <c:pt idx="6">
                  <c:v>4791.3967158433452</c:v>
                </c:pt>
                <c:pt idx="7">
                  <c:v>9.6280867498514569E-2</c:v>
                </c:pt>
                <c:pt idx="8">
                  <c:v>1457.21037385298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BE2-4A3D-87ED-00EA4E161FE9}"/>
            </c:ext>
          </c:extLst>
        </c:ser>
        <c:ser>
          <c:idx val="1"/>
          <c:order val="1"/>
          <c:tx>
            <c:strRef>
              <c:f>'\\phe.gov.uk\porton\SharedData\Diagnostic_Technologies\Papers under construction\TB Protein Biomarker paper\TB Protein Biomarker Paper working draft\Latest Draft\Final\[Copy of Supplementary Information 1d.xlsx]Sheet1'!$Y$9</c:f>
              <c:strCache>
                <c:ptCount val="1"/>
                <c:pt idx="0">
                  <c:v>A-CNTRL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\\phe.gov.uk\porton\SharedData\Diagnostic_Technologies\Papers under construction\TB Protein Biomarker paper\TB Protein Biomarker Paper working draft\Latest Draft\Final\[Copy of Supplementary Information 1d.xlsx]Sheet1'!$Z$1:$AH$1</c:f>
              <c:strCache>
                <c:ptCount val="9"/>
                <c:pt idx="0">
                  <c:v>SAMD9L</c:v>
                </c:pt>
                <c:pt idx="1">
                  <c:v>CALCOCO2</c:v>
                </c:pt>
                <c:pt idx="2">
                  <c:v>GBP1</c:v>
                </c:pt>
                <c:pt idx="3">
                  <c:v>IFITM3</c:v>
                </c:pt>
                <c:pt idx="4">
                  <c:v>SNX10</c:v>
                </c:pt>
                <c:pt idx="5">
                  <c:v>IFIT3</c:v>
                </c:pt>
                <c:pt idx="6">
                  <c:v>CD52</c:v>
                </c:pt>
                <c:pt idx="7">
                  <c:v>CD274</c:v>
                </c:pt>
                <c:pt idx="8">
                  <c:v>TMEM49</c:v>
                </c:pt>
              </c:strCache>
            </c:strRef>
          </c:cat>
          <c:val>
            <c:numRef>
              <c:f>'\\phe.gov.uk\porton\SharedData\Diagnostic_Technologies\Papers under construction\TB Protein Biomarker paper\TB Protein Biomarker Paper working draft\Latest Draft\Final\[Copy of Supplementary Information 1d.xlsx]Sheet1'!$Z$9:$AH$9</c:f>
              <c:numCache>
                <c:formatCode>General</c:formatCode>
                <c:ptCount val="9"/>
                <c:pt idx="0">
                  <c:v>2182.342553819331</c:v>
                </c:pt>
                <c:pt idx="1">
                  <c:v>1759.3558917989421</c:v>
                </c:pt>
                <c:pt idx="2">
                  <c:v>3742.8591599168531</c:v>
                </c:pt>
                <c:pt idx="3">
                  <c:v>2048.7362247999999</c:v>
                </c:pt>
                <c:pt idx="4">
                  <c:v>3222.3423157894736</c:v>
                </c:pt>
                <c:pt idx="5">
                  <c:v>20.026283520408168</c:v>
                </c:pt>
                <c:pt idx="6">
                  <c:v>4939.6262759437404</c:v>
                </c:pt>
                <c:pt idx="7">
                  <c:v>1.2695378521126768</c:v>
                </c:pt>
                <c:pt idx="8">
                  <c:v>753.841369927664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BE2-4A3D-87ED-00EA4E161FE9}"/>
            </c:ext>
          </c:extLst>
        </c:ser>
        <c:ser>
          <c:idx val="2"/>
          <c:order val="2"/>
          <c:tx>
            <c:strRef>
              <c:f>'\\phe.gov.uk\porton\SharedData\Diagnostic_Technologies\Papers under construction\TB Protein Biomarker paper\TB Protein Biomarker Paper working draft\Latest Draft\Final\[Copy of Supplementary Information 1d.xlsx]Sheet1'!$Y$10</c:f>
              <c:strCache>
                <c:ptCount val="1"/>
                <c:pt idx="0">
                  <c:v>UK-CNTRL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\\phe.gov.uk\porton\SharedData\Diagnostic_Technologies\Papers under construction\TB Protein Biomarker paper\TB Protein Biomarker Paper working draft\Latest Draft\Final\[Copy of Supplementary Information 1d.xlsx]Sheet1'!$Z$1:$AH$1</c:f>
              <c:strCache>
                <c:ptCount val="9"/>
                <c:pt idx="0">
                  <c:v>SAMD9L</c:v>
                </c:pt>
                <c:pt idx="1">
                  <c:v>CALCOCO2</c:v>
                </c:pt>
                <c:pt idx="2">
                  <c:v>GBP1</c:v>
                </c:pt>
                <c:pt idx="3">
                  <c:v>IFITM3</c:v>
                </c:pt>
                <c:pt idx="4">
                  <c:v>SNX10</c:v>
                </c:pt>
                <c:pt idx="5">
                  <c:v>IFIT3</c:v>
                </c:pt>
                <c:pt idx="6">
                  <c:v>CD52</c:v>
                </c:pt>
                <c:pt idx="7">
                  <c:v>CD274</c:v>
                </c:pt>
                <c:pt idx="8">
                  <c:v>TMEM49</c:v>
                </c:pt>
              </c:strCache>
            </c:strRef>
          </c:cat>
          <c:val>
            <c:numRef>
              <c:f>'\\phe.gov.uk\porton\SharedData\Diagnostic_Technologies\Papers under construction\TB Protein Biomarker paper\TB Protein Biomarker Paper working draft\Latest Draft\Final\[Copy of Supplementary Information 1d.xlsx]Sheet1'!$Z$10:$AH$10</c:f>
              <c:numCache>
                <c:formatCode>General</c:formatCode>
                <c:ptCount val="9"/>
                <c:pt idx="0">
                  <c:v>1454.9875597804262</c:v>
                </c:pt>
                <c:pt idx="1">
                  <c:v>1230.2033190893897</c:v>
                </c:pt>
                <c:pt idx="2">
                  <c:v>2483.8072983674983</c:v>
                </c:pt>
                <c:pt idx="3">
                  <c:v>1332.2394166666663</c:v>
                </c:pt>
                <c:pt idx="4">
                  <c:v>3230.3904244991386</c:v>
                </c:pt>
                <c:pt idx="5">
                  <c:v>9.6155107692307702</c:v>
                </c:pt>
                <c:pt idx="6">
                  <c:v>3616.0965211884109</c:v>
                </c:pt>
                <c:pt idx="7">
                  <c:v>6.0473484848484853E-2</c:v>
                </c:pt>
                <c:pt idx="8">
                  <c:v>1425.57806578036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BE2-4A3D-87ED-00EA4E161FE9}"/>
            </c:ext>
          </c:extLst>
        </c:ser>
        <c:ser>
          <c:idx val="3"/>
          <c:order val="3"/>
          <c:tx>
            <c:strRef>
              <c:f>'\\phe.gov.uk\porton\SharedData\Diagnostic_Technologies\Papers under construction\TB Protein Biomarker paper\TB Protein Biomarker Paper working draft\Latest Draft\Final\[Copy of Supplementary Information 1d.xlsx]Sheet1'!$Y$11</c:f>
              <c:strCache>
                <c:ptCount val="1"/>
                <c:pt idx="0">
                  <c:v>J-EPTB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\\phe.gov.uk\porton\SharedData\Diagnostic_Technologies\Papers under construction\TB Protein Biomarker paper\TB Protein Biomarker Paper working draft\Latest Draft\Final\[Copy of Supplementary Information 1d.xlsx]Sheet1'!$Z$1:$AH$1</c:f>
              <c:strCache>
                <c:ptCount val="9"/>
                <c:pt idx="0">
                  <c:v>SAMD9L</c:v>
                </c:pt>
                <c:pt idx="1">
                  <c:v>CALCOCO2</c:v>
                </c:pt>
                <c:pt idx="2">
                  <c:v>GBP1</c:v>
                </c:pt>
                <c:pt idx="3">
                  <c:v>IFITM3</c:v>
                </c:pt>
                <c:pt idx="4">
                  <c:v>SNX10</c:v>
                </c:pt>
                <c:pt idx="5">
                  <c:v>IFIT3</c:v>
                </c:pt>
                <c:pt idx="6">
                  <c:v>CD52</c:v>
                </c:pt>
                <c:pt idx="7">
                  <c:v>CD274</c:v>
                </c:pt>
                <c:pt idx="8">
                  <c:v>TMEM49</c:v>
                </c:pt>
              </c:strCache>
            </c:strRef>
          </c:cat>
          <c:val>
            <c:numRef>
              <c:f>'\\phe.gov.uk\porton\SharedData\Diagnostic_Technologies\Papers under construction\TB Protein Biomarker paper\TB Protein Biomarker Paper working draft\Latest Draft\Final\[Copy of Supplementary Information 1d.xlsx]Sheet1'!$Z$11:$AH$11</c:f>
              <c:numCache>
                <c:formatCode>General</c:formatCode>
                <c:ptCount val="9"/>
                <c:pt idx="0">
                  <c:v>3407.271586879433</c:v>
                </c:pt>
                <c:pt idx="1">
                  <c:v>2111.026684207337</c:v>
                </c:pt>
                <c:pt idx="2">
                  <c:v>3810.8349796096036</c:v>
                </c:pt>
                <c:pt idx="3">
                  <c:v>2541.7912784090904</c:v>
                </c:pt>
                <c:pt idx="4">
                  <c:v>4260.5521222410871</c:v>
                </c:pt>
                <c:pt idx="5">
                  <c:v>57.793749520383692</c:v>
                </c:pt>
                <c:pt idx="6">
                  <c:v>3260.9611523865133</c:v>
                </c:pt>
                <c:pt idx="7">
                  <c:v>0.99515500000000079</c:v>
                </c:pt>
                <c:pt idx="8">
                  <c:v>1274.22371201879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BE2-4A3D-87ED-00EA4E161FE9}"/>
            </c:ext>
          </c:extLst>
        </c:ser>
        <c:ser>
          <c:idx val="4"/>
          <c:order val="4"/>
          <c:tx>
            <c:strRef>
              <c:f>'\\phe.gov.uk\porton\SharedData\Diagnostic_Technologies\Papers under construction\TB Protein Biomarker paper\TB Protein Biomarker Paper working draft\Latest Draft\Final\[Copy of Supplementary Information 1d.xlsx]Sheet1'!$Y$12</c:f>
              <c:strCache>
                <c:ptCount val="1"/>
                <c:pt idx="0">
                  <c:v>A-EPTB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8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\\phe.gov.uk\porton\SharedData\Diagnostic_Technologies\Papers under construction\TB Protein Biomarker paper\TB Protein Biomarker Paper working draft\Latest Draft\Final\[Copy of Supplementary Information 1d.xlsx]Sheet1'!$Z$1:$AH$1</c:f>
              <c:strCache>
                <c:ptCount val="9"/>
                <c:pt idx="0">
                  <c:v>SAMD9L</c:v>
                </c:pt>
                <c:pt idx="1">
                  <c:v>CALCOCO2</c:v>
                </c:pt>
                <c:pt idx="2">
                  <c:v>GBP1</c:v>
                </c:pt>
                <c:pt idx="3">
                  <c:v>IFITM3</c:v>
                </c:pt>
                <c:pt idx="4">
                  <c:v>SNX10</c:v>
                </c:pt>
                <c:pt idx="5">
                  <c:v>IFIT3</c:v>
                </c:pt>
                <c:pt idx="6">
                  <c:v>CD52</c:v>
                </c:pt>
                <c:pt idx="7">
                  <c:v>CD274</c:v>
                </c:pt>
                <c:pt idx="8">
                  <c:v>TMEM49</c:v>
                </c:pt>
              </c:strCache>
            </c:strRef>
          </c:cat>
          <c:val>
            <c:numRef>
              <c:f>'\\phe.gov.uk\porton\SharedData\Diagnostic_Technologies\Papers under construction\TB Protein Biomarker paper\TB Protein Biomarker Paper working draft\Latest Draft\Final\[Copy of Supplementary Information 1d.xlsx]Sheet1'!$Z$12:$AH$12</c:f>
              <c:numCache>
                <c:formatCode>General</c:formatCode>
                <c:ptCount val="9"/>
                <c:pt idx="0">
                  <c:v>2188.2252637681163</c:v>
                </c:pt>
                <c:pt idx="1">
                  <c:v>2039.7194557142857</c:v>
                </c:pt>
                <c:pt idx="2">
                  <c:v>4458.6292007095353</c:v>
                </c:pt>
                <c:pt idx="3">
                  <c:v>2428.4022586206902</c:v>
                </c:pt>
                <c:pt idx="4">
                  <c:v>3053.7941789473675</c:v>
                </c:pt>
                <c:pt idx="5">
                  <c:v>45.098141509433979</c:v>
                </c:pt>
                <c:pt idx="6">
                  <c:v>3583.3602122333341</c:v>
                </c:pt>
                <c:pt idx="7">
                  <c:v>1.1505165000000013</c:v>
                </c:pt>
                <c:pt idx="8">
                  <c:v>682.536890805855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5BE2-4A3D-87ED-00EA4E161FE9}"/>
            </c:ext>
          </c:extLst>
        </c:ser>
        <c:ser>
          <c:idx val="5"/>
          <c:order val="5"/>
          <c:tx>
            <c:strRef>
              <c:f>'\\phe.gov.uk\porton\SharedData\Diagnostic_Technologies\Papers under construction\TB Protein Biomarker paper\TB Protein Biomarker Paper working draft\Latest Draft\Final\[Copy of Supplementary Information 1d.xlsx]Sheet1'!$Y$13</c:f>
              <c:strCache>
                <c:ptCount val="1"/>
                <c:pt idx="0">
                  <c:v>PTB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\\phe.gov.uk\porton\SharedData\Diagnostic_Technologies\Papers under construction\TB Protein Biomarker paper\TB Protein Biomarker Paper working draft\Latest Draft\Final\[Copy of Supplementary Information 1d.xlsx]Sheet1'!$Z$1:$AH$1</c:f>
              <c:strCache>
                <c:ptCount val="9"/>
                <c:pt idx="0">
                  <c:v>SAMD9L</c:v>
                </c:pt>
                <c:pt idx="1">
                  <c:v>CALCOCO2</c:v>
                </c:pt>
                <c:pt idx="2">
                  <c:v>GBP1</c:v>
                </c:pt>
                <c:pt idx="3">
                  <c:v>IFITM3</c:v>
                </c:pt>
                <c:pt idx="4">
                  <c:v>SNX10</c:v>
                </c:pt>
                <c:pt idx="5">
                  <c:v>IFIT3</c:v>
                </c:pt>
                <c:pt idx="6">
                  <c:v>CD52</c:v>
                </c:pt>
                <c:pt idx="7">
                  <c:v>CD274</c:v>
                </c:pt>
                <c:pt idx="8">
                  <c:v>TMEM49</c:v>
                </c:pt>
              </c:strCache>
            </c:strRef>
          </c:cat>
          <c:val>
            <c:numRef>
              <c:f>'\\phe.gov.uk\porton\SharedData\Diagnostic_Technologies\Papers under construction\TB Protein Biomarker paper\TB Protein Biomarker Paper working draft\Latest Draft\Final\[Copy of Supplementary Information 1d.xlsx]Sheet1'!$Z$13:$AH$13</c:f>
              <c:numCache>
                <c:formatCode>General</c:formatCode>
                <c:ptCount val="9"/>
                <c:pt idx="0">
                  <c:v>6607.2440295267043</c:v>
                </c:pt>
                <c:pt idx="1">
                  <c:v>6907.197204968943</c:v>
                </c:pt>
                <c:pt idx="2">
                  <c:v>8428.4679437036193</c:v>
                </c:pt>
                <c:pt idx="3">
                  <c:v>5433.9620535714294</c:v>
                </c:pt>
                <c:pt idx="4">
                  <c:v>5574.2668859649129</c:v>
                </c:pt>
                <c:pt idx="5">
                  <c:v>41.230765306122457</c:v>
                </c:pt>
                <c:pt idx="6">
                  <c:v>2915.4634485871275</c:v>
                </c:pt>
                <c:pt idx="7">
                  <c:v>2.207866651336591</c:v>
                </c:pt>
                <c:pt idx="8">
                  <c:v>888.5495068986484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5BE2-4A3D-87ED-00EA4E161F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94527736"/>
        <c:axId val="557167008"/>
      </c:lineChart>
      <c:catAx>
        <c:axId val="594527736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7167008"/>
        <c:crossesAt val="-2000"/>
        <c:auto val="1"/>
        <c:lblAlgn val="ctr"/>
        <c:lblOffset val="100"/>
        <c:tickMarkSkip val="1"/>
        <c:noMultiLvlLbl val="0"/>
      </c:catAx>
      <c:valAx>
        <c:axId val="557167008"/>
        <c:scaling>
          <c:orientation val="minMax"/>
          <c:max val="10000"/>
          <c:min val="-20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94527736"/>
        <c:crosses val="autoZero"/>
        <c:crossBetween val="between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66029110158248E-2"/>
          <c:y val="7.7511059127311738E-2"/>
          <c:w val="0.88343813648042635"/>
          <c:h val="0.81157563952716316"/>
        </c:manualLayout>
      </c:layout>
      <c:lineChart>
        <c:grouping val="standard"/>
        <c:varyColors val="0"/>
        <c:ser>
          <c:idx val="0"/>
          <c:order val="0"/>
          <c:tx>
            <c:strRef>
              <c:f>[1]Sheet1!$Y$2</c:f>
              <c:strCache>
                <c:ptCount val="1"/>
                <c:pt idx="0">
                  <c:v>PR AVE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square"/>
            <c:size val="8"/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1]Sheet1!$Z$1:$AH$1</c:f>
              <c:strCache>
                <c:ptCount val="9"/>
                <c:pt idx="0">
                  <c:v>SAMD9L</c:v>
                </c:pt>
                <c:pt idx="1">
                  <c:v>CALCOCO2</c:v>
                </c:pt>
                <c:pt idx="2">
                  <c:v>GBP1</c:v>
                </c:pt>
                <c:pt idx="3">
                  <c:v>IFITM3</c:v>
                </c:pt>
                <c:pt idx="4">
                  <c:v>SNX10</c:v>
                </c:pt>
                <c:pt idx="5">
                  <c:v>IFIT3</c:v>
                </c:pt>
                <c:pt idx="6">
                  <c:v>CD52</c:v>
                </c:pt>
                <c:pt idx="7">
                  <c:v>CD274</c:v>
                </c:pt>
                <c:pt idx="8">
                  <c:v>TMEM49</c:v>
                </c:pt>
              </c:strCache>
            </c:strRef>
          </c:cat>
          <c:val>
            <c:numRef>
              <c:f>[1]Sheet1!$Z$2:$AH$2</c:f>
              <c:numCache>
                <c:formatCode>General</c:formatCode>
                <c:ptCount val="9"/>
                <c:pt idx="0">
                  <c:v>860.9190774167281</c:v>
                </c:pt>
                <c:pt idx="1">
                  <c:v>1336.6862104330637</c:v>
                </c:pt>
                <c:pt idx="2">
                  <c:v>1651.4634946254516</c:v>
                </c:pt>
                <c:pt idx="3">
                  <c:v>858.77642551308645</c:v>
                </c:pt>
                <c:pt idx="4">
                  <c:v>1889.4339485725295</c:v>
                </c:pt>
                <c:pt idx="5">
                  <c:v>24.826706043956044</c:v>
                </c:pt>
                <c:pt idx="6">
                  <c:v>2050.710182550466</c:v>
                </c:pt>
                <c:pt idx="7">
                  <c:v>2.5277777777777777E-2</c:v>
                </c:pt>
                <c:pt idx="8">
                  <c:v>1384.834824209888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4C8-458D-B964-60870C32F1C4}"/>
            </c:ext>
          </c:extLst>
        </c:ser>
        <c:ser>
          <c:idx val="1"/>
          <c:order val="1"/>
          <c:tx>
            <c:strRef>
              <c:f>[1]Sheet1!$Y$5</c:f>
              <c:strCache>
                <c:ptCount val="1"/>
                <c:pt idx="0">
                  <c:v>NPR AVE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square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1]Sheet1!$Z$1:$AH$1</c:f>
              <c:strCache>
                <c:ptCount val="9"/>
                <c:pt idx="0">
                  <c:v>SAMD9L</c:v>
                </c:pt>
                <c:pt idx="1">
                  <c:v>CALCOCO2</c:v>
                </c:pt>
                <c:pt idx="2">
                  <c:v>GBP1</c:v>
                </c:pt>
                <c:pt idx="3">
                  <c:v>IFITM3</c:v>
                </c:pt>
                <c:pt idx="4">
                  <c:v>SNX10</c:v>
                </c:pt>
                <c:pt idx="5">
                  <c:v>IFIT3</c:v>
                </c:pt>
                <c:pt idx="6">
                  <c:v>CD52</c:v>
                </c:pt>
                <c:pt idx="7">
                  <c:v>CD274</c:v>
                </c:pt>
                <c:pt idx="8">
                  <c:v>TMEM49</c:v>
                </c:pt>
              </c:strCache>
            </c:strRef>
          </c:cat>
          <c:val>
            <c:numRef>
              <c:f>[1]Sheet1!$Z$5:$AH$5</c:f>
              <c:numCache>
                <c:formatCode>General</c:formatCode>
                <c:ptCount val="9"/>
                <c:pt idx="0">
                  <c:v>918.28190137389072</c:v>
                </c:pt>
                <c:pt idx="1">
                  <c:v>1362.0853019897038</c:v>
                </c:pt>
                <c:pt idx="2">
                  <c:v>2012.9056425007795</c:v>
                </c:pt>
                <c:pt idx="3">
                  <c:v>1112.2477025100834</c:v>
                </c:pt>
                <c:pt idx="4">
                  <c:v>1964.637353611841</c:v>
                </c:pt>
                <c:pt idx="5">
                  <c:v>5.8788354260232536</c:v>
                </c:pt>
                <c:pt idx="6">
                  <c:v>4471.776391000707</c:v>
                </c:pt>
                <c:pt idx="7">
                  <c:v>5.6555273368606711E-2</c:v>
                </c:pt>
                <c:pt idx="8">
                  <c:v>1149.696969600244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4C8-458D-B964-60870C32F1C4}"/>
            </c:ext>
          </c:extLst>
        </c:ser>
        <c:ser>
          <c:idx val="2"/>
          <c:order val="2"/>
          <c:tx>
            <c:strRef>
              <c:f>[1]Sheet1!$Y$8</c:f>
              <c:strCache>
                <c:ptCount val="1"/>
                <c:pt idx="0">
                  <c:v>P-CNTRL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10"/>
            <c:spPr>
              <a:solidFill>
                <a:schemeClr val="bg1">
                  <a:lumMod val="50000"/>
                </a:schemeClr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1]Sheet1!$Z$1:$AH$1</c:f>
              <c:strCache>
                <c:ptCount val="9"/>
                <c:pt idx="0">
                  <c:v>SAMD9L</c:v>
                </c:pt>
                <c:pt idx="1">
                  <c:v>CALCOCO2</c:v>
                </c:pt>
                <c:pt idx="2">
                  <c:v>GBP1</c:v>
                </c:pt>
                <c:pt idx="3">
                  <c:v>IFITM3</c:v>
                </c:pt>
                <c:pt idx="4">
                  <c:v>SNX10</c:v>
                </c:pt>
                <c:pt idx="5">
                  <c:v>IFIT3</c:v>
                </c:pt>
                <c:pt idx="6">
                  <c:v>CD52</c:v>
                </c:pt>
                <c:pt idx="7">
                  <c:v>CD274</c:v>
                </c:pt>
                <c:pt idx="8">
                  <c:v>TMEM49</c:v>
                </c:pt>
              </c:strCache>
            </c:strRef>
          </c:cat>
          <c:val>
            <c:numRef>
              <c:f>[1]Sheet1!$Z$8:$AH$8</c:f>
              <c:numCache>
                <c:formatCode>General</c:formatCode>
                <c:ptCount val="9"/>
                <c:pt idx="0">
                  <c:v>973.61786631910797</c:v>
                </c:pt>
                <c:pt idx="1">
                  <c:v>1201.1946701002489</c:v>
                </c:pt>
                <c:pt idx="2">
                  <c:v>1903.0698680713542</c:v>
                </c:pt>
                <c:pt idx="3">
                  <c:v>1110.292014678899</c:v>
                </c:pt>
                <c:pt idx="4">
                  <c:v>2017.8900205995394</c:v>
                </c:pt>
                <c:pt idx="5">
                  <c:v>0</c:v>
                </c:pt>
                <c:pt idx="6">
                  <c:v>4791.3967158433452</c:v>
                </c:pt>
                <c:pt idx="7">
                  <c:v>9.6280867498514569E-2</c:v>
                </c:pt>
                <c:pt idx="8">
                  <c:v>1457.21037385298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24C8-458D-B964-60870C32F1C4}"/>
            </c:ext>
          </c:extLst>
        </c:ser>
        <c:ser>
          <c:idx val="3"/>
          <c:order val="3"/>
          <c:tx>
            <c:strRef>
              <c:f>[1]Sheet1!$Y$9</c:f>
              <c:strCache>
                <c:ptCount val="1"/>
                <c:pt idx="0">
                  <c:v>A-CNTRL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6"/>
            <c:spPr>
              <a:solidFill>
                <a:schemeClr val="tx1"/>
              </a:solidFill>
              <a:ln w="9525">
                <a:solidFill>
                  <a:schemeClr val="tx1">
                    <a:lumMod val="75000"/>
                    <a:lumOff val="25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1]Sheet1!$Z$1:$AH$1</c:f>
              <c:strCache>
                <c:ptCount val="9"/>
                <c:pt idx="0">
                  <c:v>SAMD9L</c:v>
                </c:pt>
                <c:pt idx="1">
                  <c:v>CALCOCO2</c:v>
                </c:pt>
                <c:pt idx="2">
                  <c:v>GBP1</c:v>
                </c:pt>
                <c:pt idx="3">
                  <c:v>IFITM3</c:v>
                </c:pt>
                <c:pt idx="4">
                  <c:v>SNX10</c:v>
                </c:pt>
                <c:pt idx="5">
                  <c:v>IFIT3</c:v>
                </c:pt>
                <c:pt idx="6">
                  <c:v>CD52</c:v>
                </c:pt>
                <c:pt idx="7">
                  <c:v>CD274</c:v>
                </c:pt>
                <c:pt idx="8">
                  <c:v>TMEM49</c:v>
                </c:pt>
              </c:strCache>
            </c:strRef>
          </c:cat>
          <c:val>
            <c:numRef>
              <c:f>[1]Sheet1!$Z$9:$AH$9</c:f>
              <c:numCache>
                <c:formatCode>General</c:formatCode>
                <c:ptCount val="9"/>
                <c:pt idx="0">
                  <c:v>2182.342553819331</c:v>
                </c:pt>
                <c:pt idx="1">
                  <c:v>1759.3558917989421</c:v>
                </c:pt>
                <c:pt idx="2">
                  <c:v>3742.8591599168531</c:v>
                </c:pt>
                <c:pt idx="3">
                  <c:v>2048.7362247999999</c:v>
                </c:pt>
                <c:pt idx="4">
                  <c:v>3222.3423157894736</c:v>
                </c:pt>
                <c:pt idx="5">
                  <c:v>20.026283520408168</c:v>
                </c:pt>
                <c:pt idx="6">
                  <c:v>4939.6262759437404</c:v>
                </c:pt>
                <c:pt idx="7">
                  <c:v>1.2695378521126768</c:v>
                </c:pt>
                <c:pt idx="8">
                  <c:v>753.841369927664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24C8-458D-B964-60870C32F1C4}"/>
            </c:ext>
          </c:extLst>
        </c:ser>
        <c:ser>
          <c:idx val="4"/>
          <c:order val="4"/>
          <c:tx>
            <c:strRef>
              <c:f>[1]Sheet1!$Y$10</c:f>
              <c:strCache>
                <c:ptCount val="1"/>
                <c:pt idx="0">
                  <c:v>UK-CNTRL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noFill/>
              <a:ln w="9525">
                <a:solidFill>
                  <a:schemeClr val="tx1">
                    <a:lumMod val="75000"/>
                    <a:lumOff val="25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ysDash"/>
                <a:round/>
              </a:ln>
              <a:effectLst/>
            </c:spPr>
          </c:errBars>
          <c:cat>
            <c:strRef>
              <c:f>[1]Sheet1!$Z$1:$AH$1</c:f>
              <c:strCache>
                <c:ptCount val="9"/>
                <c:pt idx="0">
                  <c:v>SAMD9L</c:v>
                </c:pt>
                <c:pt idx="1">
                  <c:v>CALCOCO2</c:v>
                </c:pt>
                <c:pt idx="2">
                  <c:v>GBP1</c:v>
                </c:pt>
                <c:pt idx="3">
                  <c:v>IFITM3</c:v>
                </c:pt>
                <c:pt idx="4">
                  <c:v>SNX10</c:v>
                </c:pt>
                <c:pt idx="5">
                  <c:v>IFIT3</c:v>
                </c:pt>
                <c:pt idx="6">
                  <c:v>CD52</c:v>
                </c:pt>
                <c:pt idx="7">
                  <c:v>CD274</c:v>
                </c:pt>
                <c:pt idx="8">
                  <c:v>TMEM49</c:v>
                </c:pt>
              </c:strCache>
            </c:strRef>
          </c:cat>
          <c:val>
            <c:numRef>
              <c:f>[1]Sheet1!$Z$10:$AH$10</c:f>
              <c:numCache>
                <c:formatCode>General</c:formatCode>
                <c:ptCount val="9"/>
                <c:pt idx="0">
                  <c:v>1454.9875597804262</c:v>
                </c:pt>
                <c:pt idx="1">
                  <c:v>1230.2033190893897</c:v>
                </c:pt>
                <c:pt idx="2">
                  <c:v>2483.8072983674983</c:v>
                </c:pt>
                <c:pt idx="3">
                  <c:v>1332.2394166666663</c:v>
                </c:pt>
                <c:pt idx="4">
                  <c:v>3230.3904244991386</c:v>
                </c:pt>
                <c:pt idx="5">
                  <c:v>9.6155107692307702</c:v>
                </c:pt>
                <c:pt idx="6">
                  <c:v>3616.0965211884109</c:v>
                </c:pt>
                <c:pt idx="7">
                  <c:v>6.0473484848484853E-2</c:v>
                </c:pt>
                <c:pt idx="8">
                  <c:v>1425.57806578036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24C8-458D-B964-60870C32F1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94527736"/>
        <c:axId val="557167008"/>
      </c:lineChart>
      <c:catAx>
        <c:axId val="594527736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7167008"/>
        <c:crossesAt val="-2000"/>
        <c:auto val="1"/>
        <c:lblAlgn val="ctr"/>
        <c:lblOffset val="100"/>
        <c:tickMarkSkip val="1"/>
        <c:noMultiLvlLbl val="0"/>
      </c:catAx>
      <c:valAx>
        <c:axId val="557167008"/>
        <c:scaling>
          <c:orientation val="minMax"/>
          <c:max val="10000"/>
          <c:min val="-20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94527736"/>
        <c:crosses val="autoZero"/>
        <c:crossBetween val="between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2721</cdr:x>
      <cdr:y>0.42933</cdr:y>
    </cdr:from>
    <cdr:to>
      <cdr:x>0.74244</cdr:x>
      <cdr:y>0.61845</cdr:y>
    </cdr:to>
    <cdr:sp macro="" textlink="">
      <cdr:nvSpPr>
        <cdr:cNvPr id="2" name="Right Bracket 1">
          <a:extLst xmlns:a="http://schemas.openxmlformats.org/drawingml/2006/main">
            <a:ext uri="{FF2B5EF4-FFF2-40B4-BE49-F238E27FC236}">
              <a16:creationId xmlns:a16="http://schemas.microsoft.com/office/drawing/2014/main" id="{1A5327B2-6E31-4141-A74E-E47CE4E82AA0}"/>
            </a:ext>
          </a:extLst>
        </cdr:cNvPr>
        <cdr:cNvSpPr/>
      </cdr:nvSpPr>
      <cdr:spPr>
        <a:xfrm xmlns:a="http://schemas.openxmlformats.org/drawingml/2006/main">
          <a:off x="6768170" y="2608217"/>
          <a:ext cx="141746" cy="1148932"/>
        </a:xfrm>
        <a:prstGeom xmlns:a="http://schemas.openxmlformats.org/drawingml/2006/main" prst="rightBracket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7392</cdr:x>
      <cdr:y>0.47959</cdr:y>
    </cdr:from>
    <cdr:to>
      <cdr:x>0.96488</cdr:x>
      <cdr:y>0.54597</cdr:y>
    </cdr:to>
    <cdr:sp macro="" textlink="">
      <cdr:nvSpPr>
        <cdr:cNvPr id="3" name="TextBox 1">
          <a:extLst xmlns:a="http://schemas.openxmlformats.org/drawingml/2006/main">
            <a:ext uri="{FF2B5EF4-FFF2-40B4-BE49-F238E27FC236}">
              <a16:creationId xmlns:a16="http://schemas.microsoft.com/office/drawing/2014/main" id="{0716F3FF-851B-4D1C-B943-3519A3A4BC19}"/>
            </a:ext>
          </a:extLst>
        </cdr:cNvPr>
        <cdr:cNvSpPr txBox="1"/>
      </cdr:nvSpPr>
      <cdr:spPr>
        <a:xfrm xmlns:a="http://schemas.openxmlformats.org/drawingml/2006/main">
          <a:off x="6879771" y="2913588"/>
          <a:ext cx="2100345" cy="40324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100" b="1" baseline="0" dirty="0"/>
            <a:t>p  = </a:t>
          </a:r>
          <a:r>
            <a:rPr lang="en-GB" sz="1100" b="1" i="0" baseline="0" dirty="0">
              <a:effectLst/>
            </a:rPr>
            <a:t>0.00247 LTBI PR vs NPR</a:t>
          </a:r>
        </a:p>
        <a:p xmlns:a="http://schemas.openxmlformats.org/drawingml/2006/main">
          <a:r>
            <a:rPr lang="en-GB" b="1" dirty="0"/>
            <a:t>p  = 0.01005 P-CNTRL vs LTBI PR</a:t>
          </a:r>
        </a:p>
        <a:p xmlns:a="http://schemas.openxmlformats.org/drawingml/2006/main">
          <a:endParaRPr lang="en-GB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6D7637-1C7C-4042-975F-7E554C483C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A290EE0-F053-476E-A431-38121937212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508C6D-3849-4643-BDA5-27C0741BE3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7BC73-0217-49D8-9B8C-C600632C3EC6}" type="datetimeFigureOut">
              <a:rPr lang="en-GB" smtClean="0"/>
              <a:t>23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ACBBE3-70A9-4E45-817A-ADE489FE8B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909E65-B4DE-411A-96D0-26E4D22450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08754-558D-40C2-AF71-35AE389553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9673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1DB4E2-DA51-49DC-B2DC-FCAF8A9F10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0BA0C4-A2D5-42AF-B07A-046D6BE7FB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EFE26C-7B38-46F3-81AF-66D3CD4BE9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7BC73-0217-49D8-9B8C-C600632C3EC6}" type="datetimeFigureOut">
              <a:rPr lang="en-GB" smtClean="0"/>
              <a:t>23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BFA7A4-824A-4CED-99C7-45328EC9D4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9FE70C-958D-4F1A-B63D-40CF278778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08754-558D-40C2-AF71-35AE389553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3186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15DE0F-DDE6-4B5C-AA87-A6D9F24441F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7A449E-6627-41D2-A913-E8CD9A0872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4933DD-C23C-4089-81E0-E9A10E2A66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7BC73-0217-49D8-9B8C-C600632C3EC6}" type="datetimeFigureOut">
              <a:rPr lang="en-GB" smtClean="0"/>
              <a:t>23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8BA2B1-A5BE-4BAB-8815-A2EE83DBF4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88EDD0-5DEF-4C11-9C48-6EDBF34A63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08754-558D-40C2-AF71-35AE389553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77414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F20D7A-FDF2-4DF8-9C33-A42C74D56E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22AEFB-3011-4556-B65E-6486A96CEC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48E8BC-0454-4D93-9AAE-1BE67A8BC8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7BC73-0217-49D8-9B8C-C600632C3EC6}" type="datetimeFigureOut">
              <a:rPr lang="en-GB" smtClean="0"/>
              <a:t>23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D218DA-6BA4-4286-975B-C16A153E94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B5F11B-53C8-4F5C-AFC2-85CB858A76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08754-558D-40C2-AF71-35AE389553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8221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9A059B-3CF8-4DC7-B360-76F3DF0610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B82714-1627-4894-980A-DA93BCEAF8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F81CED-8E03-4E64-AC4F-D67F3A4D6E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7BC73-0217-49D8-9B8C-C600632C3EC6}" type="datetimeFigureOut">
              <a:rPr lang="en-GB" smtClean="0"/>
              <a:t>23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5B5EAB-DBB4-46E4-BCDE-2AC8101FE7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77F0B6-E48F-45FF-9EF2-4014DEFF6B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08754-558D-40C2-AF71-35AE389553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91315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9605AD-2966-4DE3-AE61-18E4EE49F2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20C43C-64DC-484B-9567-7EF479CE34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FDEAA2-0E19-4EA9-B6AA-F8F6111B5D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2427C5-C977-4B9E-98FA-EB271DB11E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7BC73-0217-49D8-9B8C-C600632C3EC6}" type="datetimeFigureOut">
              <a:rPr lang="en-GB" smtClean="0"/>
              <a:t>23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42FA6D-AA43-4C1E-8EEA-821D9A156F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D8683D-0A48-4F3C-96BC-4B25616429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08754-558D-40C2-AF71-35AE389553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55473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3A74C7-28A1-4A84-9DD7-A9C1ED0FBE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F8C1D9-6180-4600-9E58-23FB390E22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536263-FFE4-4EEE-96B4-5B174AE6A9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9037091-611C-468F-BA30-8F614C6BFAA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0025632-5361-43B5-81E0-E6B4B87814A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A5324BA-2A01-4443-B951-511908F934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7BC73-0217-49D8-9B8C-C600632C3EC6}" type="datetimeFigureOut">
              <a:rPr lang="en-GB" smtClean="0"/>
              <a:t>23/02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904119A-75D1-4D52-A06C-CB0F2185EE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BE9A5D8-5E39-4E02-AD04-84CF6EF7EF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08754-558D-40C2-AF71-35AE389553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49155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D06A7E-507D-4E70-A3D7-ACF4156FC6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57763C9-27D2-46AD-AC3C-F8B31BDE67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7BC73-0217-49D8-9B8C-C600632C3EC6}" type="datetimeFigureOut">
              <a:rPr lang="en-GB" smtClean="0"/>
              <a:t>23/02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10C3574-5727-4257-A4F9-0F06C8E7A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7BE5A58-52C1-42B4-B1FA-96AF0B9004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08754-558D-40C2-AF71-35AE389553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03008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6E9D408-6F57-4E0B-8178-2B903BEBB8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7BC73-0217-49D8-9B8C-C600632C3EC6}" type="datetimeFigureOut">
              <a:rPr lang="en-GB" smtClean="0"/>
              <a:t>23/02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1ED2D7B-03D3-40DA-A0B9-D9610929CF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1ED15EA-2293-4F3F-AA45-C76517C7AF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08754-558D-40C2-AF71-35AE389553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15134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895CCC-593D-4B02-B127-D2015CA7BF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754FF1-1324-480F-94DB-9E47DBD467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018F87E-D096-4BF6-83D3-02F6984266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83F6D4-0CFB-4BD0-8D52-E0812B5C85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7BC73-0217-49D8-9B8C-C600632C3EC6}" type="datetimeFigureOut">
              <a:rPr lang="en-GB" smtClean="0"/>
              <a:t>23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281032-F145-4257-A44F-0DE5B8443D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6D9ADD-57DA-49FA-A492-5CED333C17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08754-558D-40C2-AF71-35AE389553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65445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1012FD-A3B2-4C63-87FF-1AA0934322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B426E92-E58F-49CA-BB78-4A8A9B49BBB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F3B0890-D58F-4B45-A71E-370446B87B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A2695A-4EA7-47F8-90F7-35E9B7D252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7BC73-0217-49D8-9B8C-C600632C3EC6}" type="datetimeFigureOut">
              <a:rPr lang="en-GB" smtClean="0"/>
              <a:t>23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DD5973-7CD4-48F6-A393-33279DF643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923000-BA27-41EB-BEC5-A44C1A5CF4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08754-558D-40C2-AF71-35AE389553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38757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39C037F-B820-4D1B-BDA9-235E967290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1150FE-2483-4B58-82A6-1ABF81582A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5A6EA6-3087-462D-A084-DECA3D17EB2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E7BC73-0217-49D8-9B8C-C600632C3EC6}" type="datetimeFigureOut">
              <a:rPr lang="en-GB" smtClean="0"/>
              <a:t>23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F99310-E10F-4EFE-8030-B5E3A973FFE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88AC82-D4C9-4E7C-AAD5-CC98536960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B08754-558D-40C2-AF71-35AE389553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107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B120C85-3946-445D-9DB8-69AFF2147D36}"/>
              </a:ext>
            </a:extLst>
          </p:cNvPr>
          <p:cNvSpPr txBox="1"/>
          <p:nvPr/>
        </p:nvSpPr>
        <p:spPr>
          <a:xfrm>
            <a:off x="0" y="71120"/>
            <a:ext cx="38048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Supplementary Information Figure File S1: Figure S1.1</a:t>
            </a: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43B5EED9-F82B-4EF7-8E89-410FFDBAEDBC}"/>
              </a:ext>
            </a:extLst>
          </p:cNvPr>
          <p:cNvGraphicFramePr>
            <a:graphicFrameLocks noGrp="1"/>
          </p:cNvGraphicFramePr>
          <p:nvPr/>
        </p:nvGraphicFramePr>
        <p:xfrm>
          <a:off x="1442492" y="391425"/>
          <a:ext cx="9307015" cy="60751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7420175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B120C85-3946-445D-9DB8-69AFF2147D36}"/>
              </a:ext>
            </a:extLst>
          </p:cNvPr>
          <p:cNvSpPr txBox="1"/>
          <p:nvPr/>
        </p:nvSpPr>
        <p:spPr>
          <a:xfrm>
            <a:off x="-1" y="71120"/>
            <a:ext cx="3719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Supplementary Information Figure File S1: Figure S1.2</a:t>
            </a:r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936AF9B3-227C-4683-9A63-6F724B8AEC4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88271478"/>
              </p:ext>
            </p:extLst>
          </p:nvPr>
        </p:nvGraphicFramePr>
        <p:xfrm>
          <a:off x="1442492" y="391425"/>
          <a:ext cx="9307015" cy="60751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151BC200-2C27-409C-A950-EF41741E5F04}"/>
              </a:ext>
            </a:extLst>
          </p:cNvPr>
          <p:cNvSpPr txBox="1"/>
          <p:nvPr/>
        </p:nvSpPr>
        <p:spPr>
          <a:xfrm>
            <a:off x="4533900" y="6296025"/>
            <a:ext cx="42100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652640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</TotalTime>
  <Words>30</Words>
  <Application>Microsoft Office PowerPoint</Application>
  <PresentationFormat>Widescreen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en Kempsell</dc:creator>
  <cp:lastModifiedBy>Karen Kempsell</cp:lastModifiedBy>
  <cp:revision>8</cp:revision>
  <dcterms:created xsi:type="dcterms:W3CDTF">2021-11-11T10:33:25Z</dcterms:created>
  <dcterms:modified xsi:type="dcterms:W3CDTF">2022-02-23T18:04:51Z</dcterms:modified>
</cp:coreProperties>
</file>